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jpeg"/>
  <Default Extension="xml" ContentType="application/xml"/>
  <Override PartName="/ppt/webextensions/taskpanes.xml" ContentType="application/vnd.ms-office.webextensiontaskpanes+xml"/>
  <Override PartName="/ppt/webextensions/webextension1.xml" ContentType="application/vnd.ms-office.webextension+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thumbnail" Target="docProps/thumbnail.jpeg"/><Relationship Id="rId2" Type="http://schemas.openxmlformats.org/officeDocument/2006/relationships/officeDocument" Target="ppt/presentation.xml"/><Relationship Id="rId1" Type="http://schemas.microsoft.com/office/2011/relationships/webextensiontaskpanes" Target="ppt/webextensions/taskpanes.xml"/><Relationship Id="rId6" Type="http://schemas.openxmlformats.org/officeDocument/2006/relationships/custom-properties" Target="docProps/custom.xml"/><Relationship Id="rId5" Type="http://schemas.openxmlformats.org/officeDocument/2006/relationships/extended-properties" Target="docProps/app.xml"/><Relationship Id="rId4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358" r:id="rId5"/>
  </p:sldIdLst>
  <p:sldSz cx="6218238" cy="8229600"/>
  <p:notesSz cx="7315200" cy="9601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CE5FC"/>
    <a:srgbClr val="DCB9FF"/>
    <a:srgbClr val="009999"/>
    <a:srgbClr val="C100C1"/>
    <a:srgbClr val="FF3399"/>
    <a:srgbClr val="E80E7B"/>
    <a:srgbClr val="E1F0EE"/>
    <a:srgbClr val="FCC8F0"/>
    <a:srgbClr val="F5C71D"/>
    <a:srgbClr val="0080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17292A2E-F333-43FB-9621-5CBBE7FDCDCB}" styleName="Light Style 2 - Accent 4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</a:tcStyle>
    </a:band1H>
    <a:band1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1V>
    <a:band2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4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806" autoAdjust="0"/>
    <p:restoredTop sz="96807" autoAdjust="0"/>
  </p:normalViewPr>
  <p:slideViewPr>
    <p:cSldViewPr snapToGrid="0">
      <p:cViewPr varScale="1">
        <p:scale>
          <a:sx n="98" d="100"/>
          <a:sy n="98" d="100"/>
        </p:scale>
        <p:origin x="102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6369" y="1346836"/>
            <a:ext cx="5285502" cy="2865120"/>
          </a:xfrm>
        </p:spPr>
        <p:txBody>
          <a:bodyPr anchor="b"/>
          <a:lstStyle>
            <a:lvl1pPr algn="ctr">
              <a:defRPr sz="40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77280" y="4322446"/>
            <a:ext cx="4663679" cy="1986914"/>
          </a:xfrm>
        </p:spPr>
        <p:txBody>
          <a:bodyPr/>
          <a:lstStyle>
            <a:lvl1pPr marL="0" indent="0" algn="ctr">
              <a:buNone/>
              <a:defRPr sz="1632"/>
            </a:lvl1pPr>
            <a:lvl2pPr marL="310896" indent="0" algn="ctr">
              <a:buNone/>
              <a:defRPr sz="1360"/>
            </a:lvl2pPr>
            <a:lvl3pPr marL="621792" indent="0" algn="ctr">
              <a:buNone/>
              <a:defRPr sz="1224"/>
            </a:lvl3pPr>
            <a:lvl4pPr marL="932688" indent="0" algn="ctr">
              <a:buNone/>
              <a:defRPr sz="1088"/>
            </a:lvl4pPr>
            <a:lvl5pPr marL="1243584" indent="0" algn="ctr">
              <a:buNone/>
              <a:defRPr sz="1088"/>
            </a:lvl5pPr>
            <a:lvl6pPr marL="1554480" indent="0" algn="ctr">
              <a:buNone/>
              <a:defRPr sz="1088"/>
            </a:lvl6pPr>
            <a:lvl7pPr marL="1865376" indent="0" algn="ctr">
              <a:buNone/>
              <a:defRPr sz="1088"/>
            </a:lvl7pPr>
            <a:lvl8pPr marL="2176272" indent="0" algn="ctr">
              <a:buNone/>
              <a:defRPr sz="1088"/>
            </a:lvl8pPr>
            <a:lvl9pPr marL="2487168" indent="0" algn="ctr">
              <a:buNone/>
              <a:defRPr sz="1088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15962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5447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49927" y="438150"/>
            <a:ext cx="1340808" cy="697420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7504" y="438150"/>
            <a:ext cx="3944696" cy="697420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46520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08673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4266" y="2051688"/>
            <a:ext cx="5363231" cy="3423284"/>
          </a:xfrm>
        </p:spPr>
        <p:txBody>
          <a:bodyPr anchor="b"/>
          <a:lstStyle>
            <a:lvl1pPr>
              <a:defRPr sz="40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4266" y="5507358"/>
            <a:ext cx="5363231" cy="1800224"/>
          </a:xfrm>
        </p:spPr>
        <p:txBody>
          <a:bodyPr/>
          <a:lstStyle>
            <a:lvl1pPr marL="0" indent="0">
              <a:buNone/>
              <a:defRPr sz="1632">
                <a:solidFill>
                  <a:schemeClr val="tx1"/>
                </a:solidFill>
              </a:defRPr>
            </a:lvl1pPr>
            <a:lvl2pPr marL="310896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2pPr>
            <a:lvl3pPr marL="621792" indent="0">
              <a:buNone/>
              <a:defRPr sz="1224">
                <a:solidFill>
                  <a:schemeClr val="tx1">
                    <a:tint val="75000"/>
                  </a:schemeClr>
                </a:solidFill>
              </a:defRPr>
            </a:lvl3pPr>
            <a:lvl4pPr marL="932688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4pPr>
            <a:lvl5pPr marL="1243584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5pPr>
            <a:lvl6pPr marL="1554480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6pPr>
            <a:lvl7pPr marL="1865376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7pPr>
            <a:lvl8pPr marL="2176272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8pPr>
            <a:lvl9pPr marL="2487168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26346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7505" y="2190750"/>
            <a:ext cx="264275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47984" y="2190750"/>
            <a:ext cx="264275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40420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314" y="438152"/>
            <a:ext cx="5363231" cy="15906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8315" y="2017396"/>
            <a:ext cx="2630605" cy="988694"/>
          </a:xfrm>
        </p:spPr>
        <p:txBody>
          <a:bodyPr anchor="b"/>
          <a:lstStyle>
            <a:lvl1pPr marL="0" indent="0">
              <a:buNone/>
              <a:defRPr sz="1632" b="1"/>
            </a:lvl1pPr>
            <a:lvl2pPr marL="310896" indent="0">
              <a:buNone/>
              <a:defRPr sz="1360" b="1"/>
            </a:lvl2pPr>
            <a:lvl3pPr marL="621792" indent="0">
              <a:buNone/>
              <a:defRPr sz="1224" b="1"/>
            </a:lvl3pPr>
            <a:lvl4pPr marL="932688" indent="0">
              <a:buNone/>
              <a:defRPr sz="1088" b="1"/>
            </a:lvl4pPr>
            <a:lvl5pPr marL="1243584" indent="0">
              <a:buNone/>
              <a:defRPr sz="1088" b="1"/>
            </a:lvl5pPr>
            <a:lvl6pPr marL="1554480" indent="0">
              <a:buNone/>
              <a:defRPr sz="1088" b="1"/>
            </a:lvl6pPr>
            <a:lvl7pPr marL="1865376" indent="0">
              <a:buNone/>
              <a:defRPr sz="1088" b="1"/>
            </a:lvl7pPr>
            <a:lvl8pPr marL="2176272" indent="0">
              <a:buNone/>
              <a:defRPr sz="1088" b="1"/>
            </a:lvl8pPr>
            <a:lvl9pPr marL="2487168" indent="0">
              <a:buNone/>
              <a:defRPr sz="108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8315" y="3006090"/>
            <a:ext cx="2630605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47985" y="2017396"/>
            <a:ext cx="2643561" cy="988694"/>
          </a:xfrm>
        </p:spPr>
        <p:txBody>
          <a:bodyPr anchor="b"/>
          <a:lstStyle>
            <a:lvl1pPr marL="0" indent="0">
              <a:buNone/>
              <a:defRPr sz="1632" b="1"/>
            </a:lvl1pPr>
            <a:lvl2pPr marL="310896" indent="0">
              <a:buNone/>
              <a:defRPr sz="1360" b="1"/>
            </a:lvl2pPr>
            <a:lvl3pPr marL="621792" indent="0">
              <a:buNone/>
              <a:defRPr sz="1224" b="1"/>
            </a:lvl3pPr>
            <a:lvl4pPr marL="932688" indent="0">
              <a:buNone/>
              <a:defRPr sz="1088" b="1"/>
            </a:lvl4pPr>
            <a:lvl5pPr marL="1243584" indent="0">
              <a:buNone/>
              <a:defRPr sz="1088" b="1"/>
            </a:lvl5pPr>
            <a:lvl6pPr marL="1554480" indent="0">
              <a:buNone/>
              <a:defRPr sz="1088" b="1"/>
            </a:lvl6pPr>
            <a:lvl7pPr marL="1865376" indent="0">
              <a:buNone/>
              <a:defRPr sz="1088" b="1"/>
            </a:lvl7pPr>
            <a:lvl8pPr marL="2176272" indent="0">
              <a:buNone/>
              <a:defRPr sz="1088" b="1"/>
            </a:lvl8pPr>
            <a:lvl9pPr marL="2487168" indent="0">
              <a:buNone/>
              <a:defRPr sz="108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47985" y="3006090"/>
            <a:ext cx="2643561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70022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6216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66583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315" y="548640"/>
            <a:ext cx="2005543" cy="1920240"/>
          </a:xfrm>
        </p:spPr>
        <p:txBody>
          <a:bodyPr anchor="b"/>
          <a:lstStyle>
            <a:lvl1pPr>
              <a:defRPr sz="217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43562" y="1184912"/>
            <a:ext cx="3147982" cy="5848350"/>
          </a:xfrm>
        </p:spPr>
        <p:txBody>
          <a:bodyPr/>
          <a:lstStyle>
            <a:lvl1pPr>
              <a:defRPr sz="2176"/>
            </a:lvl1pPr>
            <a:lvl2pPr>
              <a:defRPr sz="1904"/>
            </a:lvl2pPr>
            <a:lvl3pPr>
              <a:defRPr sz="1632"/>
            </a:lvl3pPr>
            <a:lvl4pPr>
              <a:defRPr sz="1360"/>
            </a:lvl4pPr>
            <a:lvl5pPr>
              <a:defRPr sz="1360"/>
            </a:lvl5pPr>
            <a:lvl6pPr>
              <a:defRPr sz="1360"/>
            </a:lvl6pPr>
            <a:lvl7pPr>
              <a:defRPr sz="1360"/>
            </a:lvl7pPr>
            <a:lvl8pPr>
              <a:defRPr sz="1360"/>
            </a:lvl8pPr>
            <a:lvl9pPr>
              <a:defRPr sz="136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8315" y="2468880"/>
            <a:ext cx="2005543" cy="4573906"/>
          </a:xfrm>
        </p:spPr>
        <p:txBody>
          <a:bodyPr/>
          <a:lstStyle>
            <a:lvl1pPr marL="0" indent="0">
              <a:buNone/>
              <a:defRPr sz="1088"/>
            </a:lvl1pPr>
            <a:lvl2pPr marL="310896" indent="0">
              <a:buNone/>
              <a:defRPr sz="952"/>
            </a:lvl2pPr>
            <a:lvl3pPr marL="621792" indent="0">
              <a:buNone/>
              <a:defRPr sz="816"/>
            </a:lvl3pPr>
            <a:lvl4pPr marL="932688" indent="0">
              <a:buNone/>
              <a:defRPr sz="680"/>
            </a:lvl4pPr>
            <a:lvl5pPr marL="1243584" indent="0">
              <a:buNone/>
              <a:defRPr sz="680"/>
            </a:lvl5pPr>
            <a:lvl6pPr marL="1554480" indent="0">
              <a:buNone/>
              <a:defRPr sz="680"/>
            </a:lvl6pPr>
            <a:lvl7pPr marL="1865376" indent="0">
              <a:buNone/>
              <a:defRPr sz="680"/>
            </a:lvl7pPr>
            <a:lvl8pPr marL="2176272" indent="0">
              <a:buNone/>
              <a:defRPr sz="680"/>
            </a:lvl8pPr>
            <a:lvl9pPr marL="2487168" indent="0">
              <a:buNone/>
              <a:defRPr sz="68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93908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315" y="548640"/>
            <a:ext cx="2005543" cy="1920240"/>
          </a:xfrm>
        </p:spPr>
        <p:txBody>
          <a:bodyPr anchor="b"/>
          <a:lstStyle>
            <a:lvl1pPr>
              <a:defRPr sz="217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43562" y="1184912"/>
            <a:ext cx="3147982" cy="5848350"/>
          </a:xfrm>
        </p:spPr>
        <p:txBody>
          <a:bodyPr anchor="t"/>
          <a:lstStyle>
            <a:lvl1pPr marL="0" indent="0">
              <a:buNone/>
              <a:defRPr sz="2176"/>
            </a:lvl1pPr>
            <a:lvl2pPr marL="310896" indent="0">
              <a:buNone/>
              <a:defRPr sz="1904"/>
            </a:lvl2pPr>
            <a:lvl3pPr marL="621792" indent="0">
              <a:buNone/>
              <a:defRPr sz="1632"/>
            </a:lvl3pPr>
            <a:lvl4pPr marL="932688" indent="0">
              <a:buNone/>
              <a:defRPr sz="1360"/>
            </a:lvl4pPr>
            <a:lvl5pPr marL="1243584" indent="0">
              <a:buNone/>
              <a:defRPr sz="1360"/>
            </a:lvl5pPr>
            <a:lvl6pPr marL="1554480" indent="0">
              <a:buNone/>
              <a:defRPr sz="1360"/>
            </a:lvl6pPr>
            <a:lvl7pPr marL="1865376" indent="0">
              <a:buNone/>
              <a:defRPr sz="1360"/>
            </a:lvl7pPr>
            <a:lvl8pPr marL="2176272" indent="0">
              <a:buNone/>
              <a:defRPr sz="1360"/>
            </a:lvl8pPr>
            <a:lvl9pPr marL="2487168" indent="0">
              <a:buNone/>
              <a:defRPr sz="136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8315" y="2468880"/>
            <a:ext cx="2005543" cy="4573906"/>
          </a:xfrm>
        </p:spPr>
        <p:txBody>
          <a:bodyPr/>
          <a:lstStyle>
            <a:lvl1pPr marL="0" indent="0">
              <a:buNone/>
              <a:defRPr sz="1088"/>
            </a:lvl1pPr>
            <a:lvl2pPr marL="310896" indent="0">
              <a:buNone/>
              <a:defRPr sz="952"/>
            </a:lvl2pPr>
            <a:lvl3pPr marL="621792" indent="0">
              <a:buNone/>
              <a:defRPr sz="816"/>
            </a:lvl3pPr>
            <a:lvl4pPr marL="932688" indent="0">
              <a:buNone/>
              <a:defRPr sz="680"/>
            </a:lvl4pPr>
            <a:lvl5pPr marL="1243584" indent="0">
              <a:buNone/>
              <a:defRPr sz="680"/>
            </a:lvl5pPr>
            <a:lvl6pPr marL="1554480" indent="0">
              <a:buNone/>
              <a:defRPr sz="680"/>
            </a:lvl6pPr>
            <a:lvl7pPr marL="1865376" indent="0">
              <a:buNone/>
              <a:defRPr sz="680"/>
            </a:lvl7pPr>
            <a:lvl8pPr marL="2176272" indent="0">
              <a:buNone/>
              <a:defRPr sz="680"/>
            </a:lvl8pPr>
            <a:lvl9pPr marL="2487168" indent="0">
              <a:buNone/>
              <a:defRPr sz="68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3865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7504" y="438152"/>
            <a:ext cx="5363231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7504" y="2190750"/>
            <a:ext cx="5363231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7503" y="7627622"/>
            <a:ext cx="1399104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59794" y="7627622"/>
            <a:ext cx="2098655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91631" y="7627622"/>
            <a:ext cx="1399104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41346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21792" rtl="0" eaLnBrk="1" latinLnBrk="0" hangingPunct="1">
        <a:lnSpc>
          <a:spcPct val="90000"/>
        </a:lnSpc>
        <a:spcBef>
          <a:spcPct val="0"/>
        </a:spcBef>
        <a:buNone/>
        <a:defRPr sz="29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5448" indent="-155448" algn="l" defTabSz="621792" rtl="0" eaLnBrk="1" latinLnBrk="0" hangingPunct="1">
        <a:lnSpc>
          <a:spcPct val="90000"/>
        </a:lnSpc>
        <a:spcBef>
          <a:spcPts val="680"/>
        </a:spcBef>
        <a:buFont typeface="Arial" panose="020B0604020202020204" pitchFamily="34" charset="0"/>
        <a:buChar char="•"/>
        <a:defRPr sz="1904" kern="1200">
          <a:solidFill>
            <a:schemeClr val="tx1"/>
          </a:solidFill>
          <a:latin typeface="+mn-lt"/>
          <a:ea typeface="+mn-ea"/>
          <a:cs typeface="+mn-cs"/>
        </a:defRPr>
      </a:lvl1pPr>
      <a:lvl2pPr marL="466344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632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360" kern="1200">
          <a:solidFill>
            <a:schemeClr val="tx1"/>
          </a:solidFill>
          <a:latin typeface="+mn-lt"/>
          <a:ea typeface="+mn-ea"/>
          <a:cs typeface="+mn-cs"/>
        </a:defRPr>
      </a:lvl3pPr>
      <a:lvl4pPr marL="1088136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4pPr>
      <a:lvl5pPr marL="1399032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5pPr>
      <a:lvl6pPr marL="1709928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6pPr>
      <a:lvl7pPr marL="2020824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7pPr>
      <a:lvl8pPr marL="2331720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8pPr>
      <a:lvl9pPr marL="2642616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1pPr>
      <a:lvl2pPr marL="310896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2pPr>
      <a:lvl3pPr marL="621792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3pPr>
      <a:lvl4pPr marL="932688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4pPr>
      <a:lvl5pPr marL="1243584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5pPr>
      <a:lvl6pPr marL="1554480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6pPr>
      <a:lvl7pPr marL="1865376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7pPr>
      <a:lvl8pPr marL="2176272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8pPr>
      <a:lvl9pPr marL="2487168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90CD7A9-45BE-242A-686A-A2D45F2C4D24}"/>
              </a:ext>
            </a:extLst>
          </p:cNvPr>
          <p:cNvSpPr txBox="1"/>
          <p:nvPr/>
        </p:nvSpPr>
        <p:spPr>
          <a:xfrm>
            <a:off x="434473" y="837802"/>
            <a:ext cx="4977968" cy="16509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500" b="1" dirty="0">
                <a:latin typeface="Arial" panose="020B0604020202020204" pitchFamily="34" charset="0"/>
                <a:cs typeface="Arial" panose="020B0604020202020204" pitchFamily="34" charset="0"/>
              </a:rPr>
              <a:t>Source data for Figure 2C</a:t>
            </a:r>
          </a:p>
          <a:p>
            <a:pPr>
              <a:lnSpc>
                <a:spcPct val="150000"/>
              </a:lnSpc>
            </a:pP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naltered version of the gel image presented in Figure 2C are shown. Image was cropped 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and color-correcte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 PowerPoint to generate Figure 2C. </a:t>
            </a:r>
          </a:p>
        </p:txBody>
      </p:sp>
      <p:pic>
        <p:nvPicPr>
          <p:cNvPr id="6" name="Picture 5" descr="A blurry image of a moon&#10;&#10;Description automatically generated">
            <a:extLst>
              <a:ext uri="{FF2B5EF4-FFF2-40B4-BE49-F238E27FC236}">
                <a16:creationId xmlns:a16="http://schemas.microsoft.com/office/drawing/2014/main" id="{E0B7BF33-CA4B-89AA-AB47-28BFD444402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637" y="3090379"/>
            <a:ext cx="5550963" cy="23960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306964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webextensions/_rels/taskpanes.xml.rels><?xml version="1.0" encoding="UTF-8" standalone="yes"?>
<Relationships xmlns="http://schemas.openxmlformats.org/package/2006/relationships"><Relationship Id="rId1" Type="http://schemas.microsoft.com/office/2011/relationships/webextension" Target="webextension1.xml"/></Relationships>
</file>

<file path=ppt/webextensions/taskpanes.xml><?xml version="1.0" encoding="utf-8"?>
<wetp:taskpanes xmlns:wetp="http://schemas.microsoft.com/office/webextensions/taskpanes/2010/11">
  <wetp:taskpane dockstate="right" visibility="0" width="875" row="0">
    <wetp:webextensionref xmlns:r="http://schemas.openxmlformats.org/officeDocument/2006/relationships" r:id="rId1"/>
  </wetp:taskpane>
</wetp:taskpanes>
</file>

<file path=ppt/webextensions/webextension1.xml><?xml version="1.0" encoding="utf-8"?>
<we:webextension xmlns:we="http://schemas.microsoft.com/office/webextensions/webextension/2010/11" id="{2CA10241-3744-402C-BB55-0CCC07CA7F38}">
  <we:reference id="wa200006038" version="1.0.0.3" store="en-US" storeType="OMEX"/>
  <we:alternateReferences>
    <we:reference id="wa200006038" version="1.0.0.3" store="" storeType="OMEX"/>
  </we:alternateReferences>
  <we:properties/>
  <we:bindings/>
  <we:snapshot xmlns:r="http://schemas.openxmlformats.org/officeDocument/2006/relationships"/>
</we:webextension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6962610C67D4B49A88B6FAB491E3AE5" ma:contentTypeVersion="14" ma:contentTypeDescription="Create a new document." ma:contentTypeScope="" ma:versionID="bdab3a0ad6a9855bfbdcd6b489fe3c69">
  <xsd:schema xmlns:xsd="http://www.w3.org/2001/XMLSchema" xmlns:xs="http://www.w3.org/2001/XMLSchema" xmlns:p="http://schemas.microsoft.com/office/2006/metadata/properties" xmlns:ns3="18272914-71e0-42fc-9685-7c3d7493b947" xmlns:ns4="1ada6c1b-6627-4503-b0bd-5fd9b9908e29" targetNamespace="http://schemas.microsoft.com/office/2006/metadata/properties" ma:root="true" ma:fieldsID="63200ee40b5c47ed65451d97f7303378" ns3:_="" ns4:_="">
    <xsd:import namespace="18272914-71e0-42fc-9685-7c3d7493b947"/>
    <xsd:import namespace="1ada6c1b-6627-4503-b0bd-5fd9b9908e29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KeyPoints" minOccurs="0"/>
                <xsd:element ref="ns3:MediaServiceKeyPoints" minOccurs="0"/>
                <xsd:element ref="ns3:MediaServiceObjectDetectorVersions" minOccurs="0"/>
                <xsd:element ref="ns3:_activity" minOccurs="0"/>
                <xsd:element ref="ns3:MediaServiceSearchProperties" minOccurs="0"/>
                <xsd:element ref="ns3:MediaServiceSystemTags" minOccurs="0"/>
                <xsd:element ref="ns3:MediaServiceOCR" minOccurs="0"/>
                <xsd:element ref="ns3:MediaServiceGenerationTime" minOccurs="0"/>
                <xsd:element ref="ns3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8272914-71e0-42fc-9685-7c3d7493b94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ObjectDetectorVersions" ma:index="15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_activity" ma:index="16" nillable="true" ma:displayName="_activity" ma:hidden="true" ma:internalName="_activity">
      <xsd:simpleType>
        <xsd:restriction base="dms:Note"/>
      </xsd:simpleType>
    </xsd:element>
    <xsd:element name="MediaServiceSearchProperties" ma:index="17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SystemTags" ma:index="18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20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1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ada6c1b-6627-4503-b0bd-5fd9b9908e29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18272914-71e0-42fc-9685-7c3d7493b947" xsi:nil="true"/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17E71F50-D89D-49F9-A239-1B8EDA19636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8272914-71e0-42fc-9685-7c3d7493b947"/>
    <ds:schemaRef ds:uri="1ada6c1b-6627-4503-b0bd-5fd9b9908e2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2A90B254-CE57-4786-8434-001DC6CED1BB}">
  <ds:schemaRefs>
    <ds:schemaRef ds:uri="1ada6c1b-6627-4503-b0bd-5fd9b9908e29"/>
    <ds:schemaRef ds:uri="http://schemas.microsoft.com/office/infopath/2007/PartnerControls"/>
    <ds:schemaRef ds:uri="http://purl.org/dc/terms/"/>
    <ds:schemaRef ds:uri="http://purl.org/dc/elements/1.1/"/>
    <ds:schemaRef ds:uri="http://schemas.microsoft.com/office/2006/metadata/properties"/>
    <ds:schemaRef ds:uri="http://schemas.microsoft.com/office/2006/documentManagement/types"/>
    <ds:schemaRef ds:uri="18272914-71e0-42fc-9685-7c3d7493b947"/>
    <ds:schemaRef ds:uri="http://schemas.openxmlformats.org/package/2006/metadata/core-properties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9D5C7AA1-25AA-4EAE-B43E-6AED59570826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4676</TotalTime>
  <Words>30</Words>
  <Application>Microsoft Office PowerPoint</Application>
  <PresentationFormat>Custom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ubayet Elahi</dc:creator>
  <cp:lastModifiedBy>Rubayet Elahi</cp:lastModifiedBy>
  <cp:revision>1012</cp:revision>
  <cp:lastPrinted>2025-01-06T21:26:39Z</cp:lastPrinted>
  <dcterms:created xsi:type="dcterms:W3CDTF">2020-01-28T22:13:46Z</dcterms:created>
  <dcterms:modified xsi:type="dcterms:W3CDTF">2025-01-07T18:56:5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6962610C67D4B49A88B6FAB491E3AE5</vt:lpwstr>
  </property>
</Properties>
</file>